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olors1.xml" ContentType="application/vnd.ms-office.chartcolorstyle+xml"/>
  <Override PartName="/ppt/charts/colors2.xml" ContentType="application/vnd.ms-office.chartcolorstyle+xml"/>
  <Override PartName="/ppt/charts/style1.xml" ContentType="application/vnd.ms-office.chartstyle+xml"/>
  <Override PartName="/ppt/charts/style2.xml" ContentType="application/vnd.ms-office.chartstyle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365" r:id="rId3"/>
  </p:sldIdLst>
  <p:sldSz cx="9359900" cy="1151953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853" autoAdjust="0"/>
    <p:restoredTop sz="86004" autoAdjust="0"/>
  </p:normalViewPr>
  <p:slideViewPr>
    <p:cSldViewPr>
      <p:cViewPr>
        <p:scale>
          <a:sx n="70" d="100"/>
          <a:sy n="70" d="100"/>
        </p:scale>
        <p:origin x="-1284" y="-66"/>
      </p:cViewPr>
      <p:guideLst>
        <p:guide orient="horz" pos="4006"/>
        <p:guide pos="305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file:///D:\&#25910;&#32435;&#30418;&#23376;&#65288;&#30805;&#22763;&#30740;&#31350;&#29983;&#65289;\A521\D38\2018&#24180;&#32456;&#27719;&#25253;&#22270;&#34920;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oleObject" Target="file:///D:\&#25910;&#32435;&#30418;&#23376;&#65288;&#30805;&#22763;&#30740;&#31350;&#29983;&#65289;\A521\D38\2018&#24180;&#32456;&#27719;&#25253;&#22270;&#34920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651357181498454"/>
          <c:y val="0.037901675363911"/>
          <c:w val="0.815527117611213"/>
          <c:h val="0.864796310530361"/>
        </c:manualLayout>
      </c:layout>
      <c:lineChart>
        <c:grouping val="standard"/>
        <c:varyColors val="0"/>
        <c:ser>
          <c:idx val="0"/>
          <c:order val="0"/>
          <c:tx>
            <c:strRef>
              <c:f>[2018年终汇报图表.xlsx]Sheet1!$C$29</c:f>
              <c:strCache>
                <c:ptCount val="1"/>
                <c:pt idx="0">
                  <c:v>WT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3175">
                <a:solidFill>
                  <a:schemeClr val="tx1"/>
                </a:solidFill>
              </a:ln>
              <a:effectLst/>
            </c:spPr>
          </c:marker>
          <c:dLbls>
            <c:delete val="1"/>
          </c:dLbls>
          <c:errBars>
            <c:errDir val="y"/>
            <c:errBarType val="both"/>
            <c:errValType val="stdErr"/>
            <c:noEndCap val="0"/>
            <c:val val="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[2018年终汇报图表.xlsx]Sheet1!$C$30:$C$39</c:f>
              <c:numCache>
                <c:formatCode>General</c:formatCode>
                <c:ptCount val="10"/>
                <c:pt idx="0">
                  <c:v>25</c:v>
                </c:pt>
                <c:pt idx="1">
                  <c:v>30</c:v>
                </c:pt>
                <c:pt idx="2">
                  <c:v>48</c:v>
                </c:pt>
                <c:pt idx="3">
                  <c:v>75</c:v>
                </c:pt>
                <c:pt idx="4">
                  <c:v>175</c:v>
                </c:pt>
                <c:pt idx="5">
                  <c:v>240</c:v>
                </c:pt>
                <c:pt idx="6">
                  <c:v>252</c:v>
                </c:pt>
                <c:pt idx="7">
                  <c:v>273</c:v>
                </c:pt>
                <c:pt idx="8">
                  <c:v>348</c:v>
                </c:pt>
                <c:pt idx="9">
                  <c:v>422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[2018年终汇报图表.xlsx]Sheet1!$D$29</c:f>
              <c:strCache>
                <c:ptCount val="1"/>
                <c:pt idx="0">
                  <c:v>flo14</c:v>
                </c:pt>
              </c:strCache>
            </c:strRef>
          </c:tx>
          <c:spPr>
            <a:ln w="28575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lumMod val="50000"/>
                </a:schemeClr>
              </a:solidFill>
              <a:ln w="9525">
                <a:solidFill>
                  <a:schemeClr val="bg1">
                    <a:lumMod val="50000"/>
                  </a:schemeClr>
                </a:solidFill>
              </a:ln>
              <a:effectLst/>
            </c:spPr>
          </c:marker>
          <c:dLbls>
            <c:dLbl>
              <c:idx val="0"/>
              <c:delete val="1"/>
            </c:dLbl>
            <c:dLbl>
              <c:idx val="1"/>
              <c:delete val="1"/>
            </c:dLbl>
            <c:dLbl>
              <c:idx val="2"/>
              <c:delete val="1"/>
            </c:dLbl>
            <c:dLbl>
              <c:idx val="3"/>
              <c:layout/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9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12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</a:t>
                    </a:r>
                    <a:endParaRPr lang="en-US" altLang="zh-CN" sz="12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c:rich>
              </c:tx>
              <c:dLblPos val="b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4"/>
              <c:layout/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9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12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</a:t>
                    </a:r>
                    <a:endParaRPr lang="en-US" altLang="zh-CN" sz="12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c:rich>
              </c:tx>
              <c:dLblPos val="b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5"/>
              <c:layout/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9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</a:t>
                    </a:r>
                    <a:endParaRPr sz="12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c:rich>
              </c:tx>
              <c:dLblPos val="b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6"/>
              <c:layout/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9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sz="12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</a:t>
                    </a:r>
                    <a:endParaRPr sz="12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c:rich>
              </c:tx>
              <c:dLblPos val="b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7"/>
              <c:layout/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9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12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</a:t>
                    </a:r>
                    <a:endParaRPr lang="en-US" altLang="zh-CN" sz="12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c:rich>
              </c:tx>
              <c:dLblPos val="b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8"/>
              <c:layout/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9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12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</a:t>
                    </a:r>
                    <a:endParaRPr lang="en-US" altLang="zh-CN" sz="12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c:rich>
              </c:tx>
              <c:dLblPos val="b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dLbl>
              <c:idx val="9"/>
              <c:layout/>
              <c:tx>
                <c:rich>
                  <a:bodyPr rot="0" spcFirstLastPara="0" vertOverflow="ellipsis" vert="horz" wrap="square" lIns="38100" tIns="19050" rIns="38100" bIns="19050" anchor="ctr" anchorCtr="1"/>
                  <a:lstStyle/>
                  <a:p>
                    <a:pPr defTabSz="914400">
                      <a:defRPr lang="zh-CN" sz="900" b="0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12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**</a:t>
                    </a:r>
                    <a:endParaRPr lang="en-US" altLang="zh-CN" sz="120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c:rich>
              </c:tx>
              <c:dLblPos val="b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0" vertOverflow="ellipsis" vert="horz" wrap="square" lIns="38100" tIns="19050" rIns="38100" bIns="19050" anchor="ctr" anchorCtr="1"/>
              <a:lstStyle/>
              <a:p>
                <a:pPr>
                  <a:defRPr lang="zh-CN"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</a:p>
            </c:txPr>
            <c:dLblPos val="b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Dir val="y"/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[2018年终汇报图表.xlsx]Sheet1!$D$30:$D$39</c:f>
              <c:numCache>
                <c:formatCode>General</c:formatCode>
                <c:ptCount val="10"/>
                <c:pt idx="0">
                  <c:v>20</c:v>
                </c:pt>
                <c:pt idx="1">
                  <c:v>25</c:v>
                </c:pt>
                <c:pt idx="2">
                  <c:v>30</c:v>
                </c:pt>
                <c:pt idx="3">
                  <c:v>45</c:v>
                </c:pt>
                <c:pt idx="4">
                  <c:v>125</c:v>
                </c:pt>
                <c:pt idx="5">
                  <c:v>173</c:v>
                </c:pt>
                <c:pt idx="6">
                  <c:v>220</c:v>
                </c:pt>
                <c:pt idx="7">
                  <c:v>250</c:v>
                </c:pt>
                <c:pt idx="8">
                  <c:v>276</c:v>
                </c:pt>
                <c:pt idx="9">
                  <c:v>303</c:v>
                </c:pt>
              </c:numCache>
            </c:numRef>
          </c:val>
          <c:smooth val="0"/>
        </c:ser>
        <c:dLbls>
          <c:showLegendKey val="0"/>
          <c:showVal val="1"/>
          <c:showCatName val="0"/>
          <c:showSerName val="0"/>
          <c:showPercent val="0"/>
          <c:showBubbleSize val="0"/>
        </c:dLbls>
        <c:marker val="1"/>
        <c:smooth val="0"/>
        <c:axId val="688802731"/>
        <c:axId val="866827456"/>
      </c:lineChart>
      <c:catAx>
        <c:axId val="688802731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  <c:crossAx val="866827456"/>
        <c:crosses val="autoZero"/>
        <c:auto val="1"/>
        <c:lblAlgn val="ctr"/>
        <c:lblOffset val="100"/>
        <c:noMultiLvlLbl val="0"/>
      </c:catAx>
      <c:valAx>
        <c:axId val="86682745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mpd="sng">
            <a:solidFill>
              <a:schemeClr val="tx1"/>
            </a:solidFill>
            <a:prstDash val="solid"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  <c:crossAx val="688802731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legend>
      <c:legendPos val="r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egendEntry>
        <c:idx val="1"/>
        <c:txPr>
          <a:bodyPr rot="0" spcFirstLastPara="0" vertOverflow="ellipsis" vert="horz" wrap="square" anchor="ctr" anchorCtr="1"/>
          <a:lstStyle/>
          <a:p>
            <a:pPr>
              <a:defRPr lang="zh-CN" sz="900" b="0" i="1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ayout>
        <c:manualLayout>
          <c:xMode val="edge"/>
          <c:yMode val="edge"/>
          <c:x val="0.869437391420553"/>
          <c:y val="0.41128810766273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  <a:sym typeface="Times New Roman" panose="02020603050405020304" pitchFamily="18" charset="0"/>
            </a:defRPr>
          </a:pPr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88448969480777"/>
          <c:y val="0.150743865214988"/>
          <c:w val="0.83775"/>
          <c:h val="0.635509259259259"/>
        </c:manualLayout>
      </c:layout>
      <c:scatterChart>
        <c:scatterStyle val="smooth"/>
        <c:varyColors val="0"/>
        <c:ser>
          <c:idx val="0"/>
          <c:order val="0"/>
          <c:tx>
            <c:strRef>
              <c:f>"WT"</c:f>
              <c:strCache>
                <c:ptCount val="1"/>
                <c:pt idx="0">
                  <c:v>WT</c:v>
                </c:pt>
              </c:strCache>
            </c:strRef>
          </c:tx>
          <c:spPr>
            <a:ln w="1905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yVal>
            <c:numRef>
              <c:f>'D:\A521\N47\N47压缩包\N47生理生化测定\N47 RVA\[N22-N47 RVA.xlsx]N22-N47'!$C$2:$C$188</c:f>
              <c:numCache>
                <c:formatCode>General</c:formatCode>
                <c:ptCount val="187"/>
                <c:pt idx="0">
                  <c:v>70</c:v>
                </c:pt>
                <c:pt idx="1">
                  <c:v>66</c:v>
                </c:pt>
                <c:pt idx="2">
                  <c:v>41</c:v>
                </c:pt>
                <c:pt idx="3">
                  <c:v>9</c:v>
                </c:pt>
                <c:pt idx="4">
                  <c:v>5</c:v>
                </c:pt>
                <c:pt idx="5">
                  <c:v>4</c:v>
                </c:pt>
                <c:pt idx="6">
                  <c:v>4</c:v>
                </c:pt>
                <c:pt idx="7">
                  <c:v>3</c:v>
                </c:pt>
                <c:pt idx="8">
                  <c:v>3</c:v>
                </c:pt>
                <c:pt idx="9">
                  <c:v>3</c:v>
                </c:pt>
                <c:pt idx="10">
                  <c:v>3</c:v>
                </c:pt>
                <c:pt idx="11">
                  <c:v>3</c:v>
                </c:pt>
                <c:pt idx="12">
                  <c:v>3</c:v>
                </c:pt>
                <c:pt idx="13">
                  <c:v>2</c:v>
                </c:pt>
                <c:pt idx="14">
                  <c:v>2</c:v>
                </c:pt>
                <c:pt idx="15">
                  <c:v>2</c:v>
                </c:pt>
                <c:pt idx="16">
                  <c:v>2</c:v>
                </c:pt>
                <c:pt idx="17">
                  <c:v>2</c:v>
                </c:pt>
                <c:pt idx="18">
                  <c:v>2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2</c:v>
                </c:pt>
                <c:pt idx="50">
                  <c:v>3</c:v>
                </c:pt>
                <c:pt idx="51">
                  <c:v>7</c:v>
                </c:pt>
                <c:pt idx="52">
                  <c:v>16</c:v>
                </c:pt>
                <c:pt idx="53">
                  <c:v>33</c:v>
                </c:pt>
                <c:pt idx="54">
                  <c:v>65</c:v>
                </c:pt>
                <c:pt idx="55">
                  <c:v>115</c:v>
                </c:pt>
                <c:pt idx="56">
                  <c:v>173</c:v>
                </c:pt>
                <c:pt idx="57">
                  <c:v>229</c:v>
                </c:pt>
                <c:pt idx="58">
                  <c:v>277</c:v>
                </c:pt>
                <c:pt idx="59">
                  <c:v>317</c:v>
                </c:pt>
                <c:pt idx="60">
                  <c:v>354</c:v>
                </c:pt>
                <c:pt idx="61">
                  <c:v>387</c:v>
                </c:pt>
                <c:pt idx="62">
                  <c:v>419</c:v>
                </c:pt>
                <c:pt idx="63">
                  <c:v>452</c:v>
                </c:pt>
                <c:pt idx="64">
                  <c:v>487</c:v>
                </c:pt>
                <c:pt idx="65">
                  <c:v>525</c:v>
                </c:pt>
                <c:pt idx="66">
                  <c:v>569</c:v>
                </c:pt>
                <c:pt idx="67">
                  <c:v>615</c:v>
                </c:pt>
                <c:pt idx="68">
                  <c:v>669</c:v>
                </c:pt>
                <c:pt idx="69">
                  <c:v>732</c:v>
                </c:pt>
                <c:pt idx="70">
                  <c:v>803</c:v>
                </c:pt>
                <c:pt idx="71">
                  <c:v>884</c:v>
                </c:pt>
                <c:pt idx="72">
                  <c:v>974</c:v>
                </c:pt>
                <c:pt idx="73">
                  <c:v>1070</c:v>
                </c:pt>
                <c:pt idx="74">
                  <c:v>1179</c:v>
                </c:pt>
                <c:pt idx="75">
                  <c:v>1308</c:v>
                </c:pt>
                <c:pt idx="76">
                  <c:v>1463</c:v>
                </c:pt>
                <c:pt idx="77">
                  <c:v>1628</c:v>
                </c:pt>
                <c:pt idx="78">
                  <c:v>1784</c:v>
                </c:pt>
                <c:pt idx="79">
                  <c:v>1926</c:v>
                </c:pt>
                <c:pt idx="80">
                  <c:v>2055</c:v>
                </c:pt>
                <c:pt idx="81">
                  <c:v>2171</c:v>
                </c:pt>
                <c:pt idx="82">
                  <c:v>2270</c:v>
                </c:pt>
                <c:pt idx="83">
                  <c:v>2355</c:v>
                </c:pt>
                <c:pt idx="84">
                  <c:v>2428</c:v>
                </c:pt>
                <c:pt idx="85">
                  <c:v>2487</c:v>
                </c:pt>
                <c:pt idx="86">
                  <c:v>2532</c:v>
                </c:pt>
                <c:pt idx="87">
                  <c:v>2566</c:v>
                </c:pt>
                <c:pt idx="88">
                  <c:v>2590</c:v>
                </c:pt>
                <c:pt idx="89">
                  <c:v>2606</c:v>
                </c:pt>
                <c:pt idx="90">
                  <c:v>2615</c:v>
                </c:pt>
                <c:pt idx="91">
                  <c:v>2615</c:v>
                </c:pt>
                <c:pt idx="92">
                  <c:v>2609</c:v>
                </c:pt>
                <c:pt idx="93">
                  <c:v>2598</c:v>
                </c:pt>
                <c:pt idx="94">
                  <c:v>2583</c:v>
                </c:pt>
                <c:pt idx="95">
                  <c:v>2564</c:v>
                </c:pt>
                <c:pt idx="96">
                  <c:v>2542</c:v>
                </c:pt>
                <c:pt idx="97">
                  <c:v>2519</c:v>
                </c:pt>
                <c:pt idx="98">
                  <c:v>2493</c:v>
                </c:pt>
                <c:pt idx="99">
                  <c:v>2465</c:v>
                </c:pt>
                <c:pt idx="100">
                  <c:v>2437</c:v>
                </c:pt>
                <c:pt idx="101">
                  <c:v>2407</c:v>
                </c:pt>
                <c:pt idx="102">
                  <c:v>2378</c:v>
                </c:pt>
                <c:pt idx="103">
                  <c:v>2348</c:v>
                </c:pt>
                <c:pt idx="104">
                  <c:v>2317</c:v>
                </c:pt>
                <c:pt idx="105">
                  <c:v>2285</c:v>
                </c:pt>
                <c:pt idx="106">
                  <c:v>2255</c:v>
                </c:pt>
                <c:pt idx="107">
                  <c:v>2225</c:v>
                </c:pt>
                <c:pt idx="108">
                  <c:v>2195</c:v>
                </c:pt>
                <c:pt idx="109">
                  <c:v>2166</c:v>
                </c:pt>
                <c:pt idx="110">
                  <c:v>2138</c:v>
                </c:pt>
                <c:pt idx="111">
                  <c:v>2112</c:v>
                </c:pt>
                <c:pt idx="112">
                  <c:v>2089</c:v>
                </c:pt>
                <c:pt idx="113">
                  <c:v>2069</c:v>
                </c:pt>
                <c:pt idx="114">
                  <c:v>2052</c:v>
                </c:pt>
                <c:pt idx="115">
                  <c:v>2037</c:v>
                </c:pt>
                <c:pt idx="116">
                  <c:v>2025</c:v>
                </c:pt>
                <c:pt idx="117">
                  <c:v>2014</c:v>
                </c:pt>
                <c:pt idx="118">
                  <c:v>2004</c:v>
                </c:pt>
                <c:pt idx="119">
                  <c:v>1997</c:v>
                </c:pt>
                <c:pt idx="120">
                  <c:v>1989</c:v>
                </c:pt>
                <c:pt idx="121">
                  <c:v>1983</c:v>
                </c:pt>
                <c:pt idx="122">
                  <c:v>1978</c:v>
                </c:pt>
                <c:pt idx="123">
                  <c:v>1972</c:v>
                </c:pt>
                <c:pt idx="124">
                  <c:v>1969</c:v>
                </c:pt>
                <c:pt idx="125">
                  <c:v>1964</c:v>
                </c:pt>
                <c:pt idx="126">
                  <c:v>1960</c:v>
                </c:pt>
                <c:pt idx="127">
                  <c:v>1957</c:v>
                </c:pt>
                <c:pt idx="128">
                  <c:v>1955</c:v>
                </c:pt>
                <c:pt idx="129">
                  <c:v>1955</c:v>
                </c:pt>
                <c:pt idx="130">
                  <c:v>1958</c:v>
                </c:pt>
                <c:pt idx="131">
                  <c:v>1962</c:v>
                </c:pt>
                <c:pt idx="132">
                  <c:v>1968</c:v>
                </c:pt>
                <c:pt idx="133">
                  <c:v>1978</c:v>
                </c:pt>
                <c:pt idx="134">
                  <c:v>1990</c:v>
                </c:pt>
                <c:pt idx="135">
                  <c:v>2005</c:v>
                </c:pt>
                <c:pt idx="136">
                  <c:v>2024</c:v>
                </c:pt>
                <c:pt idx="137">
                  <c:v>2045</c:v>
                </c:pt>
                <c:pt idx="138">
                  <c:v>2070</c:v>
                </c:pt>
                <c:pt idx="139">
                  <c:v>2099</c:v>
                </c:pt>
                <c:pt idx="140">
                  <c:v>2131</c:v>
                </c:pt>
                <c:pt idx="141">
                  <c:v>2166</c:v>
                </c:pt>
                <c:pt idx="142">
                  <c:v>2206</c:v>
                </c:pt>
                <c:pt idx="143">
                  <c:v>2247</c:v>
                </c:pt>
                <c:pt idx="144">
                  <c:v>2292</c:v>
                </c:pt>
                <c:pt idx="145">
                  <c:v>2338</c:v>
                </c:pt>
                <c:pt idx="146">
                  <c:v>2386</c:v>
                </c:pt>
                <c:pt idx="147">
                  <c:v>2434</c:v>
                </c:pt>
                <c:pt idx="148">
                  <c:v>2486</c:v>
                </c:pt>
                <c:pt idx="149">
                  <c:v>2537</c:v>
                </c:pt>
                <c:pt idx="150">
                  <c:v>2587</c:v>
                </c:pt>
                <c:pt idx="151">
                  <c:v>2640</c:v>
                </c:pt>
                <c:pt idx="152">
                  <c:v>2691</c:v>
                </c:pt>
                <c:pt idx="153">
                  <c:v>2742</c:v>
                </c:pt>
                <c:pt idx="154">
                  <c:v>2794</c:v>
                </c:pt>
                <c:pt idx="155">
                  <c:v>2846</c:v>
                </c:pt>
                <c:pt idx="156">
                  <c:v>2898</c:v>
                </c:pt>
                <c:pt idx="157">
                  <c:v>2952</c:v>
                </c:pt>
                <c:pt idx="158">
                  <c:v>3005</c:v>
                </c:pt>
                <c:pt idx="159">
                  <c:v>3057</c:v>
                </c:pt>
                <c:pt idx="160">
                  <c:v>3106</c:v>
                </c:pt>
                <c:pt idx="161">
                  <c:v>3153</c:v>
                </c:pt>
                <c:pt idx="162">
                  <c:v>3200</c:v>
                </c:pt>
                <c:pt idx="163">
                  <c:v>3246</c:v>
                </c:pt>
                <c:pt idx="164">
                  <c:v>3292</c:v>
                </c:pt>
                <c:pt idx="165">
                  <c:v>3339</c:v>
                </c:pt>
                <c:pt idx="166">
                  <c:v>3385</c:v>
                </c:pt>
                <c:pt idx="167">
                  <c:v>3428</c:v>
                </c:pt>
                <c:pt idx="168">
                  <c:v>3469</c:v>
                </c:pt>
                <c:pt idx="169">
                  <c:v>3508</c:v>
                </c:pt>
                <c:pt idx="170">
                  <c:v>3545</c:v>
                </c:pt>
                <c:pt idx="171">
                  <c:v>3580</c:v>
                </c:pt>
                <c:pt idx="172">
                  <c:v>3609</c:v>
                </c:pt>
                <c:pt idx="173">
                  <c:v>3636</c:v>
                </c:pt>
                <c:pt idx="174">
                  <c:v>3663</c:v>
                </c:pt>
                <c:pt idx="175">
                  <c:v>3688</c:v>
                </c:pt>
                <c:pt idx="176">
                  <c:v>3711</c:v>
                </c:pt>
                <c:pt idx="177">
                  <c:v>3733</c:v>
                </c:pt>
                <c:pt idx="178">
                  <c:v>3750</c:v>
                </c:pt>
                <c:pt idx="179">
                  <c:v>3768</c:v>
                </c:pt>
                <c:pt idx="180">
                  <c:v>3785</c:v>
                </c:pt>
                <c:pt idx="181">
                  <c:v>3798</c:v>
                </c:pt>
                <c:pt idx="182">
                  <c:v>3813</c:v>
                </c:pt>
                <c:pt idx="183">
                  <c:v>3824</c:v>
                </c:pt>
                <c:pt idx="184">
                  <c:v>3831</c:v>
                </c:pt>
                <c:pt idx="185">
                  <c:v>3843</c:v>
                </c:pt>
                <c:pt idx="186">
                  <c:v>3843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"flo14"</c:f>
              <c:strCache>
                <c:ptCount val="1"/>
                <c:pt idx="0">
                  <c:v>flo14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yVal>
            <c:numRef>
              <c:f>'D:\A521\N47\N47压缩包\N47生理生化测定\N47 RVA\[N22-N47 RVA.xlsx]N22-N47'!$C$191:$C$377</c:f>
              <c:numCache>
                <c:formatCode>General</c:formatCode>
                <c:ptCount val="187"/>
                <c:pt idx="0">
                  <c:v>65</c:v>
                </c:pt>
                <c:pt idx="1">
                  <c:v>286</c:v>
                </c:pt>
                <c:pt idx="2">
                  <c:v>42</c:v>
                </c:pt>
                <c:pt idx="3">
                  <c:v>4</c:v>
                </c:pt>
                <c:pt idx="4">
                  <c:v>4</c:v>
                </c:pt>
                <c:pt idx="5">
                  <c:v>3</c:v>
                </c:pt>
                <c:pt idx="6">
                  <c:v>3</c:v>
                </c:pt>
                <c:pt idx="7">
                  <c:v>2</c:v>
                </c:pt>
                <c:pt idx="8">
                  <c:v>2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1</c:v>
                </c:pt>
                <c:pt idx="50">
                  <c:v>4</c:v>
                </c:pt>
                <c:pt idx="51">
                  <c:v>8</c:v>
                </c:pt>
                <c:pt idx="52">
                  <c:v>18</c:v>
                </c:pt>
                <c:pt idx="53">
                  <c:v>37</c:v>
                </c:pt>
                <c:pt idx="54">
                  <c:v>73</c:v>
                </c:pt>
                <c:pt idx="55">
                  <c:v>130</c:v>
                </c:pt>
                <c:pt idx="56">
                  <c:v>194</c:v>
                </c:pt>
                <c:pt idx="57">
                  <c:v>254</c:v>
                </c:pt>
                <c:pt idx="58">
                  <c:v>305</c:v>
                </c:pt>
                <c:pt idx="59">
                  <c:v>350</c:v>
                </c:pt>
                <c:pt idx="60">
                  <c:v>391</c:v>
                </c:pt>
                <c:pt idx="61">
                  <c:v>428</c:v>
                </c:pt>
                <c:pt idx="62">
                  <c:v>465</c:v>
                </c:pt>
                <c:pt idx="63">
                  <c:v>503</c:v>
                </c:pt>
                <c:pt idx="64">
                  <c:v>544</c:v>
                </c:pt>
                <c:pt idx="65">
                  <c:v>588</c:v>
                </c:pt>
                <c:pt idx="66">
                  <c:v>637</c:v>
                </c:pt>
                <c:pt idx="67">
                  <c:v>692</c:v>
                </c:pt>
                <c:pt idx="68">
                  <c:v>753</c:v>
                </c:pt>
                <c:pt idx="69">
                  <c:v>826</c:v>
                </c:pt>
                <c:pt idx="70">
                  <c:v>907</c:v>
                </c:pt>
                <c:pt idx="71">
                  <c:v>997</c:v>
                </c:pt>
                <c:pt idx="72">
                  <c:v>1094</c:v>
                </c:pt>
                <c:pt idx="73">
                  <c:v>1198</c:v>
                </c:pt>
                <c:pt idx="74">
                  <c:v>1318</c:v>
                </c:pt>
                <c:pt idx="75">
                  <c:v>1458</c:v>
                </c:pt>
                <c:pt idx="76">
                  <c:v>1620</c:v>
                </c:pt>
                <c:pt idx="77">
                  <c:v>1784</c:v>
                </c:pt>
                <c:pt idx="78">
                  <c:v>1932</c:v>
                </c:pt>
                <c:pt idx="79">
                  <c:v>2062</c:v>
                </c:pt>
                <c:pt idx="80">
                  <c:v>2180</c:v>
                </c:pt>
                <c:pt idx="81">
                  <c:v>2285</c:v>
                </c:pt>
                <c:pt idx="82">
                  <c:v>2381</c:v>
                </c:pt>
                <c:pt idx="83">
                  <c:v>2462</c:v>
                </c:pt>
                <c:pt idx="84">
                  <c:v>2529</c:v>
                </c:pt>
                <c:pt idx="85">
                  <c:v>2582</c:v>
                </c:pt>
                <c:pt idx="86">
                  <c:v>2624</c:v>
                </c:pt>
                <c:pt idx="87">
                  <c:v>2656</c:v>
                </c:pt>
                <c:pt idx="88">
                  <c:v>2678</c:v>
                </c:pt>
                <c:pt idx="89">
                  <c:v>2693</c:v>
                </c:pt>
                <c:pt idx="90">
                  <c:v>2700</c:v>
                </c:pt>
                <c:pt idx="91">
                  <c:v>2698</c:v>
                </c:pt>
                <c:pt idx="92">
                  <c:v>2693</c:v>
                </c:pt>
                <c:pt idx="93">
                  <c:v>2683</c:v>
                </c:pt>
                <c:pt idx="94">
                  <c:v>2668</c:v>
                </c:pt>
                <c:pt idx="95">
                  <c:v>2651</c:v>
                </c:pt>
                <c:pt idx="96">
                  <c:v>2629</c:v>
                </c:pt>
                <c:pt idx="97">
                  <c:v>2606</c:v>
                </c:pt>
                <c:pt idx="98">
                  <c:v>2580</c:v>
                </c:pt>
                <c:pt idx="99">
                  <c:v>2554</c:v>
                </c:pt>
                <c:pt idx="100">
                  <c:v>2525</c:v>
                </c:pt>
                <c:pt idx="101">
                  <c:v>2496</c:v>
                </c:pt>
                <c:pt idx="102">
                  <c:v>2467</c:v>
                </c:pt>
                <c:pt idx="103">
                  <c:v>2436</c:v>
                </c:pt>
                <c:pt idx="104">
                  <c:v>2406</c:v>
                </c:pt>
                <c:pt idx="105">
                  <c:v>2376</c:v>
                </c:pt>
                <c:pt idx="106">
                  <c:v>2347</c:v>
                </c:pt>
                <c:pt idx="107">
                  <c:v>2316</c:v>
                </c:pt>
                <c:pt idx="108">
                  <c:v>2288</c:v>
                </c:pt>
                <c:pt idx="109">
                  <c:v>2259</c:v>
                </c:pt>
                <c:pt idx="110">
                  <c:v>2231</c:v>
                </c:pt>
                <c:pt idx="111">
                  <c:v>2207</c:v>
                </c:pt>
                <c:pt idx="112">
                  <c:v>2186</c:v>
                </c:pt>
                <c:pt idx="113">
                  <c:v>2167</c:v>
                </c:pt>
                <c:pt idx="114">
                  <c:v>2152</c:v>
                </c:pt>
                <c:pt idx="115">
                  <c:v>2137</c:v>
                </c:pt>
                <c:pt idx="116">
                  <c:v>2125</c:v>
                </c:pt>
                <c:pt idx="117">
                  <c:v>2115</c:v>
                </c:pt>
                <c:pt idx="118">
                  <c:v>2106</c:v>
                </c:pt>
                <c:pt idx="119">
                  <c:v>2098</c:v>
                </c:pt>
                <c:pt idx="120">
                  <c:v>2092</c:v>
                </c:pt>
                <c:pt idx="121">
                  <c:v>2086</c:v>
                </c:pt>
                <c:pt idx="122">
                  <c:v>2079</c:v>
                </c:pt>
                <c:pt idx="123">
                  <c:v>2074</c:v>
                </c:pt>
                <c:pt idx="124">
                  <c:v>2070</c:v>
                </c:pt>
                <c:pt idx="125">
                  <c:v>2065</c:v>
                </c:pt>
                <c:pt idx="126">
                  <c:v>2061</c:v>
                </c:pt>
                <c:pt idx="127">
                  <c:v>2059</c:v>
                </c:pt>
                <c:pt idx="128">
                  <c:v>2057</c:v>
                </c:pt>
                <c:pt idx="129">
                  <c:v>2056</c:v>
                </c:pt>
                <c:pt idx="130">
                  <c:v>2058</c:v>
                </c:pt>
                <c:pt idx="131">
                  <c:v>2061</c:v>
                </c:pt>
                <c:pt idx="132">
                  <c:v>2067</c:v>
                </c:pt>
                <c:pt idx="133">
                  <c:v>2076</c:v>
                </c:pt>
                <c:pt idx="134">
                  <c:v>2088</c:v>
                </c:pt>
                <c:pt idx="135">
                  <c:v>2103</c:v>
                </c:pt>
                <c:pt idx="136">
                  <c:v>2122</c:v>
                </c:pt>
                <c:pt idx="137">
                  <c:v>2143</c:v>
                </c:pt>
                <c:pt idx="138">
                  <c:v>2166</c:v>
                </c:pt>
                <c:pt idx="139">
                  <c:v>2195</c:v>
                </c:pt>
                <c:pt idx="140">
                  <c:v>2227</c:v>
                </c:pt>
                <c:pt idx="141">
                  <c:v>2262</c:v>
                </c:pt>
                <c:pt idx="142">
                  <c:v>2300</c:v>
                </c:pt>
                <c:pt idx="143">
                  <c:v>2341</c:v>
                </c:pt>
                <c:pt idx="144">
                  <c:v>2384</c:v>
                </c:pt>
                <c:pt idx="145">
                  <c:v>2428</c:v>
                </c:pt>
                <c:pt idx="146">
                  <c:v>2475</c:v>
                </c:pt>
                <c:pt idx="147">
                  <c:v>2522</c:v>
                </c:pt>
                <c:pt idx="148">
                  <c:v>2571</c:v>
                </c:pt>
                <c:pt idx="149">
                  <c:v>2621</c:v>
                </c:pt>
                <c:pt idx="150">
                  <c:v>2670</c:v>
                </c:pt>
                <c:pt idx="151">
                  <c:v>2719</c:v>
                </c:pt>
                <c:pt idx="152">
                  <c:v>2770</c:v>
                </c:pt>
                <c:pt idx="153">
                  <c:v>2821</c:v>
                </c:pt>
                <c:pt idx="154">
                  <c:v>2875</c:v>
                </c:pt>
                <c:pt idx="155">
                  <c:v>2927</c:v>
                </c:pt>
                <c:pt idx="156">
                  <c:v>2977</c:v>
                </c:pt>
                <c:pt idx="157">
                  <c:v>3028</c:v>
                </c:pt>
                <c:pt idx="158">
                  <c:v>3074</c:v>
                </c:pt>
                <c:pt idx="159">
                  <c:v>3120</c:v>
                </c:pt>
                <c:pt idx="160">
                  <c:v>3167</c:v>
                </c:pt>
                <c:pt idx="161">
                  <c:v>3212</c:v>
                </c:pt>
                <c:pt idx="162">
                  <c:v>3257</c:v>
                </c:pt>
                <c:pt idx="163">
                  <c:v>3301</c:v>
                </c:pt>
                <c:pt idx="164">
                  <c:v>3345</c:v>
                </c:pt>
                <c:pt idx="165">
                  <c:v>3388</c:v>
                </c:pt>
                <c:pt idx="166">
                  <c:v>3432</c:v>
                </c:pt>
                <c:pt idx="167">
                  <c:v>3471</c:v>
                </c:pt>
                <c:pt idx="168">
                  <c:v>3508</c:v>
                </c:pt>
                <c:pt idx="169">
                  <c:v>3543</c:v>
                </c:pt>
                <c:pt idx="170">
                  <c:v>3578</c:v>
                </c:pt>
                <c:pt idx="171">
                  <c:v>3608</c:v>
                </c:pt>
                <c:pt idx="172">
                  <c:v>3636</c:v>
                </c:pt>
                <c:pt idx="173">
                  <c:v>3663</c:v>
                </c:pt>
                <c:pt idx="174">
                  <c:v>3688</c:v>
                </c:pt>
                <c:pt idx="175">
                  <c:v>3712</c:v>
                </c:pt>
                <c:pt idx="176">
                  <c:v>3733</c:v>
                </c:pt>
                <c:pt idx="177">
                  <c:v>3753</c:v>
                </c:pt>
                <c:pt idx="178">
                  <c:v>3770</c:v>
                </c:pt>
                <c:pt idx="179">
                  <c:v>3786</c:v>
                </c:pt>
                <c:pt idx="180">
                  <c:v>3802</c:v>
                </c:pt>
                <c:pt idx="181">
                  <c:v>3814</c:v>
                </c:pt>
                <c:pt idx="182">
                  <c:v>3829</c:v>
                </c:pt>
                <c:pt idx="183">
                  <c:v>3839</c:v>
                </c:pt>
                <c:pt idx="184">
                  <c:v>3848</c:v>
                </c:pt>
                <c:pt idx="185">
                  <c:v>3856</c:v>
                </c:pt>
                <c:pt idx="186">
                  <c:v>3856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50936495"/>
        <c:axId val="653640822"/>
      </c:scatterChart>
      <c:scatterChart>
        <c:scatterStyle val="smooth"/>
        <c:varyColors val="0"/>
        <c:ser>
          <c:idx val="2"/>
          <c:order val="2"/>
          <c:tx>
            <c:strRef>
              <c:f>'D:\A521\N47\N47压缩包\N47生理生化测定\N47 RVA\[N22-N47 RVA.xlsx]N22-N47'!$D$1</c:f>
              <c:strCache>
                <c:ptCount val="1"/>
                <c:pt idx="0">
                  <c:v>Temp(℃)</c:v>
                </c:pt>
              </c:strCache>
            </c:strRef>
          </c:tx>
          <c:spPr>
            <a:ln w="19050" cap="rnd">
              <a:solidFill>
                <a:srgbClr val="C00000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yVal>
            <c:numRef>
              <c:f>'D:\A521\N47\N47压缩包\N47生理生化测定\N47 RVA\[N22-N47 RVA.xlsx]N22-N47'!$D$2:$D$188</c:f>
              <c:numCache>
                <c:formatCode>General</c:formatCode>
                <c:ptCount val="187"/>
                <c:pt idx="0">
                  <c:v>47.45</c:v>
                </c:pt>
                <c:pt idx="1">
                  <c:v>48.95</c:v>
                </c:pt>
                <c:pt idx="2">
                  <c:v>49.9</c:v>
                </c:pt>
                <c:pt idx="3">
                  <c:v>50.1</c:v>
                </c:pt>
                <c:pt idx="4">
                  <c:v>50.15</c:v>
                </c:pt>
                <c:pt idx="5">
                  <c:v>50.2</c:v>
                </c:pt>
                <c:pt idx="6">
                  <c:v>50.3</c:v>
                </c:pt>
                <c:pt idx="7">
                  <c:v>50.35</c:v>
                </c:pt>
                <c:pt idx="8">
                  <c:v>50.35</c:v>
                </c:pt>
                <c:pt idx="9">
                  <c:v>50.35</c:v>
                </c:pt>
                <c:pt idx="10">
                  <c:v>50.3</c:v>
                </c:pt>
                <c:pt idx="11">
                  <c:v>50.3</c:v>
                </c:pt>
                <c:pt idx="12">
                  <c:v>50.25</c:v>
                </c:pt>
                <c:pt idx="13">
                  <c:v>50.2</c:v>
                </c:pt>
                <c:pt idx="14">
                  <c:v>50.25</c:v>
                </c:pt>
                <c:pt idx="15">
                  <c:v>50.6</c:v>
                </c:pt>
                <c:pt idx="16">
                  <c:v>51.2</c:v>
                </c:pt>
                <c:pt idx="17">
                  <c:v>52</c:v>
                </c:pt>
                <c:pt idx="18">
                  <c:v>52.9</c:v>
                </c:pt>
                <c:pt idx="19">
                  <c:v>53.6</c:v>
                </c:pt>
                <c:pt idx="20">
                  <c:v>54.55</c:v>
                </c:pt>
                <c:pt idx="21">
                  <c:v>55.3</c:v>
                </c:pt>
                <c:pt idx="22">
                  <c:v>56.3</c:v>
                </c:pt>
                <c:pt idx="23">
                  <c:v>57.2</c:v>
                </c:pt>
                <c:pt idx="24">
                  <c:v>58</c:v>
                </c:pt>
                <c:pt idx="25">
                  <c:v>58.95</c:v>
                </c:pt>
                <c:pt idx="26">
                  <c:v>59.85</c:v>
                </c:pt>
                <c:pt idx="27">
                  <c:v>60.6</c:v>
                </c:pt>
                <c:pt idx="28">
                  <c:v>61.5</c:v>
                </c:pt>
                <c:pt idx="29">
                  <c:v>62.25</c:v>
                </c:pt>
                <c:pt idx="30">
                  <c:v>63.15</c:v>
                </c:pt>
                <c:pt idx="31">
                  <c:v>64</c:v>
                </c:pt>
                <c:pt idx="32">
                  <c:v>64.7</c:v>
                </c:pt>
                <c:pt idx="33">
                  <c:v>65.55</c:v>
                </c:pt>
                <c:pt idx="34">
                  <c:v>66.45</c:v>
                </c:pt>
                <c:pt idx="35">
                  <c:v>67.15</c:v>
                </c:pt>
                <c:pt idx="36">
                  <c:v>68.05</c:v>
                </c:pt>
                <c:pt idx="37">
                  <c:v>68.75</c:v>
                </c:pt>
                <c:pt idx="38">
                  <c:v>69.55</c:v>
                </c:pt>
                <c:pt idx="39">
                  <c:v>70.4</c:v>
                </c:pt>
                <c:pt idx="40">
                  <c:v>71.1</c:v>
                </c:pt>
                <c:pt idx="41">
                  <c:v>71.95</c:v>
                </c:pt>
                <c:pt idx="42">
                  <c:v>72.8</c:v>
                </c:pt>
                <c:pt idx="43">
                  <c:v>73.5</c:v>
                </c:pt>
                <c:pt idx="44">
                  <c:v>74.4</c:v>
                </c:pt>
                <c:pt idx="45">
                  <c:v>75.05</c:v>
                </c:pt>
                <c:pt idx="46">
                  <c:v>75.9</c:v>
                </c:pt>
                <c:pt idx="47">
                  <c:v>76.7</c:v>
                </c:pt>
                <c:pt idx="48">
                  <c:v>77.45</c:v>
                </c:pt>
                <c:pt idx="49">
                  <c:v>78.25</c:v>
                </c:pt>
                <c:pt idx="50">
                  <c:v>79.1</c:v>
                </c:pt>
                <c:pt idx="51">
                  <c:v>79.85</c:v>
                </c:pt>
                <c:pt idx="52">
                  <c:v>80.7</c:v>
                </c:pt>
                <c:pt idx="53">
                  <c:v>81.4</c:v>
                </c:pt>
                <c:pt idx="54">
                  <c:v>82.25</c:v>
                </c:pt>
                <c:pt idx="55">
                  <c:v>83.1</c:v>
                </c:pt>
                <c:pt idx="56">
                  <c:v>83.85</c:v>
                </c:pt>
                <c:pt idx="57">
                  <c:v>84.7</c:v>
                </c:pt>
                <c:pt idx="58">
                  <c:v>85.5</c:v>
                </c:pt>
                <c:pt idx="59">
                  <c:v>86.15</c:v>
                </c:pt>
                <c:pt idx="60">
                  <c:v>87.05</c:v>
                </c:pt>
                <c:pt idx="61">
                  <c:v>87.7</c:v>
                </c:pt>
                <c:pt idx="62">
                  <c:v>88.55</c:v>
                </c:pt>
                <c:pt idx="63">
                  <c:v>89.35</c:v>
                </c:pt>
                <c:pt idx="64">
                  <c:v>90.1</c:v>
                </c:pt>
                <c:pt idx="65">
                  <c:v>90.95</c:v>
                </c:pt>
                <c:pt idx="66">
                  <c:v>91.75</c:v>
                </c:pt>
                <c:pt idx="67">
                  <c:v>92.45</c:v>
                </c:pt>
                <c:pt idx="68">
                  <c:v>93.3</c:v>
                </c:pt>
                <c:pt idx="69">
                  <c:v>93.95</c:v>
                </c:pt>
                <c:pt idx="70">
                  <c:v>94.8</c:v>
                </c:pt>
                <c:pt idx="71">
                  <c:v>95.05</c:v>
                </c:pt>
                <c:pt idx="72">
                  <c:v>94.65</c:v>
                </c:pt>
                <c:pt idx="73">
                  <c:v>94.5</c:v>
                </c:pt>
                <c:pt idx="74">
                  <c:v>94.6</c:v>
                </c:pt>
                <c:pt idx="75">
                  <c:v>94.75</c:v>
                </c:pt>
                <c:pt idx="76">
                  <c:v>94.8</c:v>
                </c:pt>
                <c:pt idx="77">
                  <c:v>94.9</c:v>
                </c:pt>
                <c:pt idx="78">
                  <c:v>94.95</c:v>
                </c:pt>
                <c:pt idx="79">
                  <c:v>94.95</c:v>
                </c:pt>
                <c:pt idx="80">
                  <c:v>95</c:v>
                </c:pt>
                <c:pt idx="81">
                  <c:v>95</c:v>
                </c:pt>
                <c:pt idx="82">
                  <c:v>95</c:v>
                </c:pt>
                <c:pt idx="83">
                  <c:v>95</c:v>
                </c:pt>
                <c:pt idx="84">
                  <c:v>95</c:v>
                </c:pt>
                <c:pt idx="85">
                  <c:v>95.05</c:v>
                </c:pt>
                <c:pt idx="86">
                  <c:v>95.05</c:v>
                </c:pt>
                <c:pt idx="87">
                  <c:v>95.05</c:v>
                </c:pt>
                <c:pt idx="88">
                  <c:v>95</c:v>
                </c:pt>
                <c:pt idx="89">
                  <c:v>95.05</c:v>
                </c:pt>
                <c:pt idx="90">
                  <c:v>95.05</c:v>
                </c:pt>
                <c:pt idx="91">
                  <c:v>95.05</c:v>
                </c:pt>
                <c:pt idx="92">
                  <c:v>95.05</c:v>
                </c:pt>
                <c:pt idx="93">
                  <c:v>95</c:v>
                </c:pt>
                <c:pt idx="94">
                  <c:v>95.05</c:v>
                </c:pt>
                <c:pt idx="95">
                  <c:v>95.05</c:v>
                </c:pt>
                <c:pt idx="96">
                  <c:v>95.05</c:v>
                </c:pt>
                <c:pt idx="97">
                  <c:v>95</c:v>
                </c:pt>
                <c:pt idx="98">
                  <c:v>95</c:v>
                </c:pt>
                <c:pt idx="99">
                  <c:v>95</c:v>
                </c:pt>
                <c:pt idx="100">
                  <c:v>95</c:v>
                </c:pt>
                <c:pt idx="101">
                  <c:v>95</c:v>
                </c:pt>
                <c:pt idx="102">
                  <c:v>95</c:v>
                </c:pt>
                <c:pt idx="103">
                  <c:v>95</c:v>
                </c:pt>
                <c:pt idx="104">
                  <c:v>95</c:v>
                </c:pt>
                <c:pt idx="105">
                  <c:v>95</c:v>
                </c:pt>
                <c:pt idx="106">
                  <c:v>95</c:v>
                </c:pt>
                <c:pt idx="107">
                  <c:v>95</c:v>
                </c:pt>
                <c:pt idx="108">
                  <c:v>95</c:v>
                </c:pt>
                <c:pt idx="109">
                  <c:v>94.6</c:v>
                </c:pt>
                <c:pt idx="110">
                  <c:v>93.45</c:v>
                </c:pt>
                <c:pt idx="111">
                  <c:v>92.5</c:v>
                </c:pt>
                <c:pt idx="112">
                  <c:v>91.85</c:v>
                </c:pt>
                <c:pt idx="113">
                  <c:v>91</c:v>
                </c:pt>
                <c:pt idx="114">
                  <c:v>89.95</c:v>
                </c:pt>
                <c:pt idx="115">
                  <c:v>89.3</c:v>
                </c:pt>
                <c:pt idx="116">
                  <c:v>88.4</c:v>
                </c:pt>
                <c:pt idx="117">
                  <c:v>87.65</c:v>
                </c:pt>
                <c:pt idx="118">
                  <c:v>86.7</c:v>
                </c:pt>
                <c:pt idx="119">
                  <c:v>86.15</c:v>
                </c:pt>
                <c:pt idx="120">
                  <c:v>85.2</c:v>
                </c:pt>
                <c:pt idx="121">
                  <c:v>84.4</c:v>
                </c:pt>
                <c:pt idx="122">
                  <c:v>83.6</c:v>
                </c:pt>
                <c:pt idx="123">
                  <c:v>82.8</c:v>
                </c:pt>
                <c:pt idx="124">
                  <c:v>82.1</c:v>
                </c:pt>
                <c:pt idx="125">
                  <c:v>81.25</c:v>
                </c:pt>
                <c:pt idx="126">
                  <c:v>80.5</c:v>
                </c:pt>
                <c:pt idx="127">
                  <c:v>79.65</c:v>
                </c:pt>
                <c:pt idx="128">
                  <c:v>78.95</c:v>
                </c:pt>
                <c:pt idx="129">
                  <c:v>78.1</c:v>
                </c:pt>
                <c:pt idx="130">
                  <c:v>77.2</c:v>
                </c:pt>
                <c:pt idx="131">
                  <c:v>76.6</c:v>
                </c:pt>
                <c:pt idx="132">
                  <c:v>75.65</c:v>
                </c:pt>
                <c:pt idx="133">
                  <c:v>75.1</c:v>
                </c:pt>
                <c:pt idx="134">
                  <c:v>74.15</c:v>
                </c:pt>
                <c:pt idx="135">
                  <c:v>73.25</c:v>
                </c:pt>
                <c:pt idx="136">
                  <c:v>72.65</c:v>
                </c:pt>
                <c:pt idx="137">
                  <c:v>71.7</c:v>
                </c:pt>
                <c:pt idx="138">
                  <c:v>70.95</c:v>
                </c:pt>
                <c:pt idx="139">
                  <c:v>70.15</c:v>
                </c:pt>
                <c:pt idx="140">
                  <c:v>69.4</c:v>
                </c:pt>
                <c:pt idx="141">
                  <c:v>68.65</c:v>
                </c:pt>
                <c:pt idx="142">
                  <c:v>67.85</c:v>
                </c:pt>
                <c:pt idx="143">
                  <c:v>67.05</c:v>
                </c:pt>
                <c:pt idx="144">
                  <c:v>66.3</c:v>
                </c:pt>
                <c:pt idx="145">
                  <c:v>65.55</c:v>
                </c:pt>
                <c:pt idx="146">
                  <c:v>64.6</c:v>
                </c:pt>
                <c:pt idx="147">
                  <c:v>64.05</c:v>
                </c:pt>
                <c:pt idx="148">
                  <c:v>63.1</c:v>
                </c:pt>
                <c:pt idx="149">
                  <c:v>62.45</c:v>
                </c:pt>
                <c:pt idx="150">
                  <c:v>61.65</c:v>
                </c:pt>
                <c:pt idx="151">
                  <c:v>60.7</c:v>
                </c:pt>
                <c:pt idx="152">
                  <c:v>60.15</c:v>
                </c:pt>
                <c:pt idx="153">
                  <c:v>59.2</c:v>
                </c:pt>
                <c:pt idx="154">
                  <c:v>58.35</c:v>
                </c:pt>
                <c:pt idx="155">
                  <c:v>57.65</c:v>
                </c:pt>
                <c:pt idx="156">
                  <c:v>56.8</c:v>
                </c:pt>
                <c:pt idx="157">
                  <c:v>56.15</c:v>
                </c:pt>
                <c:pt idx="158">
                  <c:v>55.25</c:v>
                </c:pt>
                <c:pt idx="159">
                  <c:v>54.6</c:v>
                </c:pt>
                <c:pt idx="160">
                  <c:v>53.7</c:v>
                </c:pt>
                <c:pt idx="161">
                  <c:v>53</c:v>
                </c:pt>
                <c:pt idx="162">
                  <c:v>52.15</c:v>
                </c:pt>
                <c:pt idx="163">
                  <c:v>51.4</c:v>
                </c:pt>
                <c:pt idx="164">
                  <c:v>50.7</c:v>
                </c:pt>
                <c:pt idx="165">
                  <c:v>50.05</c:v>
                </c:pt>
                <c:pt idx="166">
                  <c:v>49.95</c:v>
                </c:pt>
                <c:pt idx="167">
                  <c:v>50</c:v>
                </c:pt>
                <c:pt idx="168">
                  <c:v>50</c:v>
                </c:pt>
                <c:pt idx="169">
                  <c:v>50</c:v>
                </c:pt>
                <c:pt idx="170">
                  <c:v>50.05</c:v>
                </c:pt>
                <c:pt idx="171">
                  <c:v>50.05</c:v>
                </c:pt>
                <c:pt idx="172">
                  <c:v>50</c:v>
                </c:pt>
                <c:pt idx="173">
                  <c:v>50.05</c:v>
                </c:pt>
                <c:pt idx="174">
                  <c:v>50</c:v>
                </c:pt>
                <c:pt idx="175">
                  <c:v>50</c:v>
                </c:pt>
                <c:pt idx="176">
                  <c:v>50</c:v>
                </c:pt>
                <c:pt idx="177">
                  <c:v>50</c:v>
                </c:pt>
                <c:pt idx="178">
                  <c:v>50</c:v>
                </c:pt>
                <c:pt idx="179">
                  <c:v>49.95</c:v>
                </c:pt>
                <c:pt idx="180">
                  <c:v>50</c:v>
                </c:pt>
                <c:pt idx="181">
                  <c:v>50</c:v>
                </c:pt>
                <c:pt idx="182">
                  <c:v>50</c:v>
                </c:pt>
                <c:pt idx="183">
                  <c:v>49.95</c:v>
                </c:pt>
                <c:pt idx="184">
                  <c:v>50</c:v>
                </c:pt>
                <c:pt idx="185">
                  <c:v>50</c:v>
                </c:pt>
                <c:pt idx="186">
                  <c:v>50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75590207"/>
        <c:axId val="772007288"/>
      </c:scatterChart>
      <c:valAx>
        <c:axId val="750936495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  <c:crossAx val="653640822"/>
        <c:crosses val="autoZero"/>
        <c:crossBetween val="midCat"/>
        <c:majorUnit val="40"/>
      </c:valAx>
      <c:valAx>
        <c:axId val="653640822"/>
        <c:scaling>
          <c:orientation val="minMax"/>
          <c:max val="50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  <c:crossAx val="750936495"/>
        <c:crosses val="autoZero"/>
        <c:crossBetween val="midCat"/>
        <c:majorUnit val="1000"/>
      </c:valAx>
      <c:valAx>
        <c:axId val="975590207"/>
        <c:scaling>
          <c:orientation val="minMax"/>
        </c:scaling>
        <c:delete val="1"/>
        <c:axPos val="b"/>
        <c:majorTickMark val="none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</a:p>
        </c:txPr>
        <c:crossAx val="772007288"/>
        <c:crosses val="autoZero"/>
        <c:crossBetween val="midCat"/>
      </c:valAx>
      <c:valAx>
        <c:axId val="772007288"/>
        <c:scaling>
          <c:orientation val="minMax"/>
        </c:scaling>
        <c:delete val="0"/>
        <c:axPos val="r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  <c:crossAx val="975590207"/>
        <c:crosses val="max"/>
        <c:crossBetween val="midCat"/>
        <c:majorUnit val="20"/>
      </c:valAx>
      <c:spPr>
        <a:noFill/>
        <a:ln>
          <a:solidFill>
            <a:schemeClr val="bg1"/>
          </a:solidFill>
        </a:ln>
        <a:effectLst/>
      </c:spPr>
    </c:plotArea>
    <c:legend>
      <c:legendPos val="b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egendEntry>
        <c:idx val="1"/>
        <c:txPr>
          <a:bodyPr rot="0" spcFirstLastPara="0" vertOverflow="ellipsis" vert="horz" wrap="square" anchor="ctr" anchorCtr="1"/>
          <a:lstStyle/>
          <a:p>
            <a:pPr>
              <a:defRPr lang="zh-CN" sz="900" b="0" i="1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egendEntry>
        <c:idx val="2"/>
        <c:txPr>
          <a:bodyPr rot="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Times New Roman" panose="02020603050405020304" pitchFamily="18" charset="0"/>
              </a:defRPr>
            </a:pPr>
          </a:p>
        </c:txPr>
      </c:legendEntry>
      <c:layout/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  <a:sym typeface="Times New Roman" panose="02020603050405020304" pitchFamily="18" charset="0"/>
            </a:defRPr>
          </a:pPr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4507FC-E56F-457C-BCC0-1ED82018DCCB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035969" y="685800"/>
            <a:ext cx="2786062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50F900-E9C4-4B5A-A470-FC885A58795B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altLang="zh-CN" dirty="0">
              <a:sym typeface="+mn-ea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150F900-E9C4-4B5A-A470-FC885A58795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702033" y="3578713"/>
            <a:ext cx="7956355" cy="246936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404062" y="6528070"/>
            <a:ext cx="6552293" cy="294403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613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1233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846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2466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8079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3693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9312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4926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786305" y="461343"/>
            <a:ext cx="2106094" cy="982943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68021" y="461343"/>
            <a:ext cx="6162275" cy="982943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39410" y="7402748"/>
            <a:ext cx="7956355" cy="2288025"/>
          </a:xfrm>
        </p:spPr>
        <p:txBody>
          <a:bodyPr anchor="t"/>
          <a:lstStyle>
            <a:lvl1pPr algn="l">
              <a:defRPr sz="4915" b="1" cap="all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39410" y="4882720"/>
            <a:ext cx="7956355" cy="2520026"/>
          </a:xfrm>
        </p:spPr>
        <p:txBody>
          <a:bodyPr anchor="b"/>
          <a:lstStyle>
            <a:lvl1pPr marL="0" indent="0">
              <a:buNone/>
              <a:defRPr sz="2455">
                <a:solidFill>
                  <a:schemeClr val="tx1">
                    <a:tint val="75000"/>
                  </a:schemeClr>
                </a:solidFill>
              </a:defRPr>
            </a:lvl1pPr>
            <a:lvl2pPr marL="561340" indent="0">
              <a:buNone/>
              <a:defRPr sz="2210">
                <a:solidFill>
                  <a:schemeClr val="tx1">
                    <a:tint val="75000"/>
                  </a:schemeClr>
                </a:solidFill>
              </a:defRPr>
            </a:lvl2pPr>
            <a:lvl3pPr marL="1123315" indent="0">
              <a:buNone/>
              <a:defRPr sz="1965">
                <a:solidFill>
                  <a:schemeClr val="tx1">
                    <a:tint val="75000"/>
                  </a:schemeClr>
                </a:solidFill>
              </a:defRPr>
            </a:lvl3pPr>
            <a:lvl4pPr marL="1684655" indent="0">
              <a:buNone/>
              <a:defRPr sz="1720">
                <a:solidFill>
                  <a:schemeClr val="tx1">
                    <a:tint val="75000"/>
                  </a:schemeClr>
                </a:solidFill>
              </a:defRPr>
            </a:lvl4pPr>
            <a:lvl5pPr marL="2246630" indent="0">
              <a:buNone/>
              <a:defRPr sz="1720">
                <a:solidFill>
                  <a:schemeClr val="tx1">
                    <a:tint val="75000"/>
                  </a:schemeClr>
                </a:solidFill>
              </a:defRPr>
            </a:lvl5pPr>
            <a:lvl6pPr marL="2807970" indent="0">
              <a:buNone/>
              <a:defRPr sz="1720">
                <a:solidFill>
                  <a:schemeClr val="tx1">
                    <a:tint val="75000"/>
                  </a:schemeClr>
                </a:solidFill>
              </a:defRPr>
            </a:lvl6pPr>
            <a:lvl7pPr marL="3369310" indent="0">
              <a:buNone/>
              <a:defRPr sz="1720">
                <a:solidFill>
                  <a:schemeClr val="tx1">
                    <a:tint val="75000"/>
                  </a:schemeClr>
                </a:solidFill>
              </a:defRPr>
            </a:lvl7pPr>
            <a:lvl8pPr marL="3931285" indent="0">
              <a:buNone/>
              <a:defRPr sz="1720">
                <a:solidFill>
                  <a:schemeClr val="tx1">
                    <a:tint val="75000"/>
                  </a:schemeClr>
                </a:solidFill>
              </a:defRPr>
            </a:lvl8pPr>
            <a:lvl9pPr marL="4492625" indent="0">
              <a:buNone/>
              <a:defRPr sz="17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68023" y="2688029"/>
            <a:ext cx="4134184" cy="7602749"/>
          </a:xfrm>
        </p:spPr>
        <p:txBody>
          <a:bodyPr/>
          <a:lstStyle>
            <a:lvl1pPr>
              <a:defRPr sz="3440"/>
            </a:lvl1pPr>
            <a:lvl2pPr>
              <a:defRPr sz="2950"/>
            </a:lvl2pPr>
            <a:lvl3pPr>
              <a:defRPr sz="2455"/>
            </a:lvl3pPr>
            <a:lvl4pPr>
              <a:defRPr sz="2210"/>
            </a:lvl4pPr>
            <a:lvl5pPr>
              <a:defRPr sz="2210"/>
            </a:lvl5pPr>
            <a:lvl6pPr>
              <a:defRPr sz="2210"/>
            </a:lvl6pPr>
            <a:lvl7pPr>
              <a:defRPr sz="2210"/>
            </a:lvl7pPr>
            <a:lvl8pPr>
              <a:defRPr sz="2210"/>
            </a:lvl8pPr>
            <a:lvl9pPr>
              <a:defRPr sz="221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58217" y="2688029"/>
            <a:ext cx="4134184" cy="7602749"/>
          </a:xfrm>
        </p:spPr>
        <p:txBody>
          <a:bodyPr/>
          <a:lstStyle>
            <a:lvl1pPr>
              <a:defRPr sz="3440"/>
            </a:lvl1pPr>
            <a:lvl2pPr>
              <a:defRPr sz="2950"/>
            </a:lvl2pPr>
            <a:lvl3pPr>
              <a:defRPr sz="2455"/>
            </a:lvl3pPr>
            <a:lvl4pPr>
              <a:defRPr sz="2210"/>
            </a:lvl4pPr>
            <a:lvl5pPr>
              <a:defRPr sz="2210"/>
            </a:lvl5pPr>
            <a:lvl6pPr>
              <a:defRPr sz="2210"/>
            </a:lvl6pPr>
            <a:lvl7pPr>
              <a:defRPr sz="2210"/>
            </a:lvl7pPr>
            <a:lvl8pPr>
              <a:defRPr sz="2210"/>
            </a:lvl8pPr>
            <a:lvl9pPr>
              <a:defRPr sz="221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8020" y="2578701"/>
            <a:ext cx="4135811" cy="1074677"/>
          </a:xfrm>
        </p:spPr>
        <p:txBody>
          <a:bodyPr anchor="b"/>
          <a:lstStyle>
            <a:lvl1pPr marL="0" indent="0">
              <a:buNone/>
              <a:defRPr sz="2950" b="1"/>
            </a:lvl1pPr>
            <a:lvl2pPr marL="561340" indent="0">
              <a:buNone/>
              <a:defRPr sz="2455" b="1"/>
            </a:lvl2pPr>
            <a:lvl3pPr marL="1123315" indent="0">
              <a:buNone/>
              <a:defRPr sz="2210" b="1"/>
            </a:lvl3pPr>
            <a:lvl4pPr marL="1684655" indent="0">
              <a:buNone/>
              <a:defRPr sz="1965" b="1"/>
            </a:lvl4pPr>
            <a:lvl5pPr marL="2246630" indent="0">
              <a:buNone/>
              <a:defRPr sz="1965" b="1"/>
            </a:lvl5pPr>
            <a:lvl6pPr marL="2807970" indent="0">
              <a:buNone/>
              <a:defRPr sz="1965" b="1"/>
            </a:lvl6pPr>
            <a:lvl7pPr marL="3369310" indent="0">
              <a:buNone/>
              <a:defRPr sz="1965" b="1"/>
            </a:lvl7pPr>
            <a:lvl8pPr marL="3931285" indent="0">
              <a:buNone/>
              <a:defRPr sz="1965" b="1"/>
            </a:lvl8pPr>
            <a:lvl9pPr marL="4492625" indent="0">
              <a:buNone/>
              <a:defRPr sz="1965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8020" y="3653375"/>
            <a:ext cx="4135811" cy="6637405"/>
          </a:xfrm>
        </p:spPr>
        <p:txBody>
          <a:bodyPr/>
          <a:lstStyle>
            <a:lvl1pPr>
              <a:defRPr sz="2950"/>
            </a:lvl1pPr>
            <a:lvl2pPr>
              <a:defRPr sz="2455"/>
            </a:lvl2pPr>
            <a:lvl3pPr>
              <a:defRPr sz="2210"/>
            </a:lvl3pPr>
            <a:lvl4pPr>
              <a:defRPr sz="1965"/>
            </a:lvl4pPr>
            <a:lvl5pPr>
              <a:defRPr sz="1965"/>
            </a:lvl5pPr>
            <a:lvl6pPr>
              <a:defRPr sz="1965"/>
            </a:lvl6pPr>
            <a:lvl7pPr>
              <a:defRPr sz="1965"/>
            </a:lvl7pPr>
            <a:lvl8pPr>
              <a:defRPr sz="1965"/>
            </a:lvl8pPr>
            <a:lvl9pPr>
              <a:defRPr sz="196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754962" y="2578701"/>
            <a:ext cx="4137436" cy="1074677"/>
          </a:xfrm>
        </p:spPr>
        <p:txBody>
          <a:bodyPr anchor="b"/>
          <a:lstStyle>
            <a:lvl1pPr marL="0" indent="0">
              <a:buNone/>
              <a:defRPr sz="2950" b="1"/>
            </a:lvl1pPr>
            <a:lvl2pPr marL="561340" indent="0">
              <a:buNone/>
              <a:defRPr sz="2455" b="1"/>
            </a:lvl2pPr>
            <a:lvl3pPr marL="1123315" indent="0">
              <a:buNone/>
              <a:defRPr sz="2210" b="1"/>
            </a:lvl3pPr>
            <a:lvl4pPr marL="1684655" indent="0">
              <a:buNone/>
              <a:defRPr sz="1965" b="1"/>
            </a:lvl4pPr>
            <a:lvl5pPr marL="2246630" indent="0">
              <a:buNone/>
              <a:defRPr sz="1965" b="1"/>
            </a:lvl5pPr>
            <a:lvl6pPr marL="2807970" indent="0">
              <a:buNone/>
              <a:defRPr sz="1965" b="1"/>
            </a:lvl6pPr>
            <a:lvl7pPr marL="3369310" indent="0">
              <a:buNone/>
              <a:defRPr sz="1965" b="1"/>
            </a:lvl7pPr>
            <a:lvl8pPr marL="3931285" indent="0">
              <a:buNone/>
              <a:defRPr sz="1965" b="1"/>
            </a:lvl8pPr>
            <a:lvl9pPr marL="4492625" indent="0">
              <a:buNone/>
              <a:defRPr sz="1965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754962" y="3653375"/>
            <a:ext cx="4137436" cy="6637405"/>
          </a:xfrm>
        </p:spPr>
        <p:txBody>
          <a:bodyPr/>
          <a:lstStyle>
            <a:lvl1pPr>
              <a:defRPr sz="2950"/>
            </a:lvl1pPr>
            <a:lvl2pPr>
              <a:defRPr sz="2455"/>
            </a:lvl2pPr>
            <a:lvl3pPr>
              <a:defRPr sz="2210"/>
            </a:lvl3pPr>
            <a:lvl4pPr>
              <a:defRPr sz="1965"/>
            </a:lvl4pPr>
            <a:lvl5pPr>
              <a:defRPr sz="1965"/>
            </a:lvl5pPr>
            <a:lvl6pPr>
              <a:defRPr sz="1965"/>
            </a:lvl6pPr>
            <a:lvl7pPr>
              <a:defRPr sz="1965"/>
            </a:lvl7pPr>
            <a:lvl8pPr>
              <a:defRPr sz="1965"/>
            </a:lvl8pPr>
            <a:lvl9pPr>
              <a:defRPr sz="196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8022" y="458672"/>
            <a:ext cx="3079514" cy="1952021"/>
          </a:xfrm>
        </p:spPr>
        <p:txBody>
          <a:bodyPr anchor="b"/>
          <a:lstStyle>
            <a:lvl1pPr algn="l">
              <a:defRPr sz="2455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659663" y="458672"/>
            <a:ext cx="5232734" cy="9832105"/>
          </a:xfrm>
        </p:spPr>
        <p:txBody>
          <a:bodyPr/>
          <a:lstStyle>
            <a:lvl1pPr>
              <a:defRPr sz="3930"/>
            </a:lvl1pPr>
            <a:lvl2pPr>
              <a:defRPr sz="3440"/>
            </a:lvl2pPr>
            <a:lvl3pPr>
              <a:defRPr sz="2950"/>
            </a:lvl3pPr>
            <a:lvl4pPr>
              <a:defRPr sz="2455"/>
            </a:lvl4pPr>
            <a:lvl5pPr>
              <a:defRPr sz="2455"/>
            </a:lvl5pPr>
            <a:lvl6pPr>
              <a:defRPr sz="2455"/>
            </a:lvl6pPr>
            <a:lvl7pPr>
              <a:defRPr sz="2455"/>
            </a:lvl7pPr>
            <a:lvl8pPr>
              <a:defRPr sz="2455"/>
            </a:lvl8pPr>
            <a:lvl9pPr>
              <a:defRPr sz="245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68022" y="2410695"/>
            <a:ext cx="3079514" cy="7880085"/>
          </a:xfrm>
        </p:spPr>
        <p:txBody>
          <a:bodyPr/>
          <a:lstStyle>
            <a:lvl1pPr marL="0" indent="0">
              <a:buNone/>
              <a:defRPr sz="1720"/>
            </a:lvl1pPr>
            <a:lvl2pPr marL="561340" indent="0">
              <a:buNone/>
              <a:defRPr sz="1475"/>
            </a:lvl2pPr>
            <a:lvl3pPr marL="1123315" indent="0">
              <a:buNone/>
              <a:defRPr sz="1230"/>
            </a:lvl3pPr>
            <a:lvl4pPr marL="1684655" indent="0">
              <a:buNone/>
              <a:defRPr sz="1105"/>
            </a:lvl4pPr>
            <a:lvl5pPr marL="2246630" indent="0">
              <a:buNone/>
              <a:defRPr sz="1105"/>
            </a:lvl5pPr>
            <a:lvl6pPr marL="2807970" indent="0">
              <a:buNone/>
              <a:defRPr sz="1105"/>
            </a:lvl6pPr>
            <a:lvl7pPr marL="3369310" indent="0">
              <a:buNone/>
              <a:defRPr sz="1105"/>
            </a:lvl7pPr>
            <a:lvl8pPr marL="3931285" indent="0">
              <a:buNone/>
              <a:defRPr sz="1105"/>
            </a:lvl8pPr>
            <a:lvl9pPr marL="4492625" indent="0">
              <a:buNone/>
              <a:defRPr sz="110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834707" y="8064086"/>
            <a:ext cx="5616251" cy="952012"/>
          </a:xfrm>
        </p:spPr>
        <p:txBody>
          <a:bodyPr anchor="b"/>
          <a:lstStyle>
            <a:lvl1pPr algn="l">
              <a:defRPr sz="2455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834707" y="1029345"/>
            <a:ext cx="5616251" cy="6912074"/>
          </a:xfrm>
        </p:spPr>
        <p:txBody>
          <a:bodyPr/>
          <a:lstStyle>
            <a:lvl1pPr marL="0" indent="0">
              <a:buNone/>
              <a:defRPr sz="3930"/>
            </a:lvl1pPr>
            <a:lvl2pPr marL="561340" indent="0">
              <a:buNone/>
              <a:defRPr sz="3440"/>
            </a:lvl2pPr>
            <a:lvl3pPr marL="1123315" indent="0">
              <a:buNone/>
              <a:defRPr sz="2950"/>
            </a:lvl3pPr>
            <a:lvl4pPr marL="1684655" indent="0">
              <a:buNone/>
              <a:defRPr sz="2455"/>
            </a:lvl4pPr>
            <a:lvl5pPr marL="2246630" indent="0">
              <a:buNone/>
              <a:defRPr sz="2455"/>
            </a:lvl5pPr>
            <a:lvl6pPr marL="2807970" indent="0">
              <a:buNone/>
              <a:defRPr sz="2455"/>
            </a:lvl6pPr>
            <a:lvl7pPr marL="3369310" indent="0">
              <a:buNone/>
              <a:defRPr sz="2455"/>
            </a:lvl7pPr>
            <a:lvl8pPr marL="3931285" indent="0">
              <a:buNone/>
              <a:defRPr sz="2455"/>
            </a:lvl8pPr>
            <a:lvl9pPr marL="4492625" indent="0">
              <a:buNone/>
              <a:defRPr sz="245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834707" y="9016098"/>
            <a:ext cx="5616251" cy="1352013"/>
          </a:xfrm>
        </p:spPr>
        <p:txBody>
          <a:bodyPr/>
          <a:lstStyle>
            <a:lvl1pPr marL="0" indent="0">
              <a:buNone/>
              <a:defRPr sz="1720"/>
            </a:lvl1pPr>
            <a:lvl2pPr marL="561340" indent="0">
              <a:buNone/>
              <a:defRPr sz="1475"/>
            </a:lvl2pPr>
            <a:lvl3pPr marL="1123315" indent="0">
              <a:buNone/>
              <a:defRPr sz="1230"/>
            </a:lvl3pPr>
            <a:lvl4pPr marL="1684655" indent="0">
              <a:buNone/>
              <a:defRPr sz="1105"/>
            </a:lvl4pPr>
            <a:lvl5pPr marL="2246630" indent="0">
              <a:buNone/>
              <a:defRPr sz="1105"/>
            </a:lvl5pPr>
            <a:lvl6pPr marL="2807970" indent="0">
              <a:buNone/>
              <a:defRPr sz="1105"/>
            </a:lvl6pPr>
            <a:lvl7pPr marL="3369310" indent="0">
              <a:buNone/>
              <a:defRPr sz="1105"/>
            </a:lvl7pPr>
            <a:lvl8pPr marL="3931285" indent="0">
              <a:buNone/>
              <a:defRPr sz="1105"/>
            </a:lvl8pPr>
            <a:lvl9pPr marL="4492625" indent="0">
              <a:buNone/>
              <a:defRPr sz="110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68022" y="461339"/>
            <a:ext cx="8424376" cy="192002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8022" y="2688029"/>
            <a:ext cx="8424376" cy="760274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68020" y="10677455"/>
            <a:ext cx="2184097" cy="6133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98144" y="10677455"/>
            <a:ext cx="2964132" cy="6133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708301" y="10677455"/>
            <a:ext cx="2184097" cy="6133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123315" rtl="0" eaLnBrk="1" latinLnBrk="0" hangingPunct="1">
        <a:spcBef>
          <a:spcPct val="0"/>
        </a:spcBef>
        <a:buNone/>
        <a:defRPr sz="540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21005" indent="-421005" algn="l" defTabSz="1123315" rtl="0" eaLnBrk="1" latinLnBrk="0" hangingPunct="1">
        <a:spcBef>
          <a:spcPts val="120"/>
        </a:spcBef>
        <a:buFont typeface="Arial" panose="020B0604020202020204" pitchFamily="34" charset="0"/>
        <a:buChar char="•"/>
        <a:defRPr sz="3930" kern="1200">
          <a:solidFill>
            <a:schemeClr val="tx1"/>
          </a:solidFill>
          <a:latin typeface="+mn-lt"/>
          <a:ea typeface="+mn-ea"/>
          <a:cs typeface="+mn-cs"/>
        </a:defRPr>
      </a:lvl1pPr>
      <a:lvl2pPr marL="912495" indent="-351155" algn="l" defTabSz="1123315" rtl="0" eaLnBrk="1" latinLnBrk="0" hangingPunct="1">
        <a:spcBef>
          <a:spcPts val="120"/>
        </a:spcBef>
        <a:buFont typeface="Arial" panose="020B0604020202020204" pitchFamily="34" charset="0"/>
        <a:buChar char="–"/>
        <a:defRPr sz="3440" kern="1200">
          <a:solidFill>
            <a:schemeClr val="tx1"/>
          </a:solidFill>
          <a:latin typeface="+mn-lt"/>
          <a:ea typeface="+mn-ea"/>
          <a:cs typeface="+mn-cs"/>
        </a:defRPr>
      </a:lvl2pPr>
      <a:lvl3pPr marL="1403985" indent="-280670" algn="l" defTabSz="1123315" rtl="0" eaLnBrk="1" latinLnBrk="0" hangingPunct="1">
        <a:spcBef>
          <a:spcPts val="120"/>
        </a:spcBef>
        <a:buFont typeface="Arial" panose="020B0604020202020204" pitchFamily="34" charset="0"/>
        <a:buChar char="•"/>
        <a:defRPr sz="2950" kern="1200">
          <a:solidFill>
            <a:schemeClr val="tx1"/>
          </a:solidFill>
          <a:latin typeface="+mn-lt"/>
          <a:ea typeface="+mn-ea"/>
          <a:cs typeface="+mn-cs"/>
        </a:defRPr>
      </a:lvl3pPr>
      <a:lvl4pPr marL="1965325" indent="-280670" algn="l" defTabSz="1123315" rtl="0" eaLnBrk="1" latinLnBrk="0" hangingPunct="1">
        <a:spcBef>
          <a:spcPts val="120"/>
        </a:spcBef>
        <a:buFont typeface="Arial" panose="020B0604020202020204" pitchFamily="34" charset="0"/>
        <a:buChar char="–"/>
        <a:defRPr sz="2455" kern="1200">
          <a:solidFill>
            <a:schemeClr val="tx1"/>
          </a:solidFill>
          <a:latin typeface="+mn-lt"/>
          <a:ea typeface="+mn-ea"/>
          <a:cs typeface="+mn-cs"/>
        </a:defRPr>
      </a:lvl4pPr>
      <a:lvl5pPr marL="2527300" indent="-280670" algn="l" defTabSz="1123315" rtl="0" eaLnBrk="1" latinLnBrk="0" hangingPunct="1">
        <a:spcBef>
          <a:spcPts val="120"/>
        </a:spcBef>
        <a:buFont typeface="Arial" panose="020B0604020202020204" pitchFamily="34" charset="0"/>
        <a:buChar char="»"/>
        <a:defRPr sz="2455" kern="1200">
          <a:solidFill>
            <a:schemeClr val="tx1"/>
          </a:solidFill>
          <a:latin typeface="+mn-lt"/>
          <a:ea typeface="+mn-ea"/>
          <a:cs typeface="+mn-cs"/>
        </a:defRPr>
      </a:lvl5pPr>
      <a:lvl6pPr marL="3088640" indent="-280670" algn="l" defTabSz="1123315" rtl="0" eaLnBrk="1" latinLnBrk="0" hangingPunct="1">
        <a:spcBef>
          <a:spcPts val="120"/>
        </a:spcBef>
        <a:buFont typeface="Arial" panose="020B0604020202020204" pitchFamily="34" charset="0"/>
        <a:buChar char="•"/>
        <a:defRPr sz="2455" kern="1200">
          <a:solidFill>
            <a:schemeClr val="tx1"/>
          </a:solidFill>
          <a:latin typeface="+mn-lt"/>
          <a:ea typeface="+mn-ea"/>
          <a:cs typeface="+mn-cs"/>
        </a:defRPr>
      </a:lvl6pPr>
      <a:lvl7pPr marL="3650615" indent="-280670" algn="l" defTabSz="1123315" rtl="0" eaLnBrk="1" latinLnBrk="0" hangingPunct="1">
        <a:spcBef>
          <a:spcPts val="120"/>
        </a:spcBef>
        <a:buFont typeface="Arial" panose="020B0604020202020204" pitchFamily="34" charset="0"/>
        <a:buChar char="•"/>
        <a:defRPr sz="2455" kern="1200">
          <a:solidFill>
            <a:schemeClr val="tx1"/>
          </a:solidFill>
          <a:latin typeface="+mn-lt"/>
          <a:ea typeface="+mn-ea"/>
          <a:cs typeface="+mn-cs"/>
        </a:defRPr>
      </a:lvl7pPr>
      <a:lvl8pPr marL="4211955" indent="-280670" algn="l" defTabSz="1123315" rtl="0" eaLnBrk="1" latinLnBrk="0" hangingPunct="1">
        <a:spcBef>
          <a:spcPts val="120"/>
        </a:spcBef>
        <a:buFont typeface="Arial" panose="020B0604020202020204" pitchFamily="34" charset="0"/>
        <a:buChar char="•"/>
        <a:defRPr sz="2455" kern="1200">
          <a:solidFill>
            <a:schemeClr val="tx1"/>
          </a:solidFill>
          <a:latin typeface="+mn-lt"/>
          <a:ea typeface="+mn-ea"/>
          <a:cs typeface="+mn-cs"/>
        </a:defRPr>
      </a:lvl8pPr>
      <a:lvl9pPr marL="4773295" indent="-280670" algn="l" defTabSz="1123315" rtl="0" eaLnBrk="1" latinLnBrk="0" hangingPunct="1">
        <a:spcBef>
          <a:spcPts val="120"/>
        </a:spcBef>
        <a:buFont typeface="Arial" panose="020B0604020202020204" pitchFamily="34" charset="0"/>
        <a:buChar char="•"/>
        <a:defRPr sz="245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123315" rtl="0" eaLnBrk="1" latinLnBrk="0" hangingPunct="1">
        <a:defRPr sz="2210" kern="1200">
          <a:solidFill>
            <a:schemeClr val="tx1"/>
          </a:solidFill>
          <a:latin typeface="+mn-lt"/>
          <a:ea typeface="+mn-ea"/>
          <a:cs typeface="+mn-cs"/>
        </a:defRPr>
      </a:lvl1pPr>
      <a:lvl2pPr marL="561340" algn="l" defTabSz="1123315" rtl="0" eaLnBrk="1" latinLnBrk="0" hangingPunct="1">
        <a:defRPr sz="2210" kern="1200">
          <a:solidFill>
            <a:schemeClr val="tx1"/>
          </a:solidFill>
          <a:latin typeface="+mn-lt"/>
          <a:ea typeface="+mn-ea"/>
          <a:cs typeface="+mn-cs"/>
        </a:defRPr>
      </a:lvl2pPr>
      <a:lvl3pPr marL="1123315" algn="l" defTabSz="1123315" rtl="0" eaLnBrk="1" latinLnBrk="0" hangingPunct="1">
        <a:defRPr sz="2210" kern="1200">
          <a:solidFill>
            <a:schemeClr val="tx1"/>
          </a:solidFill>
          <a:latin typeface="+mn-lt"/>
          <a:ea typeface="+mn-ea"/>
          <a:cs typeface="+mn-cs"/>
        </a:defRPr>
      </a:lvl3pPr>
      <a:lvl4pPr marL="1684655" algn="l" defTabSz="1123315" rtl="0" eaLnBrk="1" latinLnBrk="0" hangingPunct="1">
        <a:defRPr sz="2210" kern="1200">
          <a:solidFill>
            <a:schemeClr val="tx1"/>
          </a:solidFill>
          <a:latin typeface="+mn-lt"/>
          <a:ea typeface="+mn-ea"/>
          <a:cs typeface="+mn-cs"/>
        </a:defRPr>
      </a:lvl4pPr>
      <a:lvl5pPr marL="2246630" algn="l" defTabSz="1123315" rtl="0" eaLnBrk="1" latinLnBrk="0" hangingPunct="1">
        <a:defRPr sz="2210" kern="1200">
          <a:solidFill>
            <a:schemeClr val="tx1"/>
          </a:solidFill>
          <a:latin typeface="+mn-lt"/>
          <a:ea typeface="+mn-ea"/>
          <a:cs typeface="+mn-cs"/>
        </a:defRPr>
      </a:lvl5pPr>
      <a:lvl6pPr marL="2807970" algn="l" defTabSz="1123315" rtl="0" eaLnBrk="1" latinLnBrk="0" hangingPunct="1">
        <a:defRPr sz="2210" kern="1200">
          <a:solidFill>
            <a:schemeClr val="tx1"/>
          </a:solidFill>
          <a:latin typeface="+mn-lt"/>
          <a:ea typeface="+mn-ea"/>
          <a:cs typeface="+mn-cs"/>
        </a:defRPr>
      </a:lvl6pPr>
      <a:lvl7pPr marL="3369310" algn="l" defTabSz="1123315" rtl="0" eaLnBrk="1" latinLnBrk="0" hangingPunct="1">
        <a:defRPr sz="2210" kern="1200">
          <a:solidFill>
            <a:schemeClr val="tx1"/>
          </a:solidFill>
          <a:latin typeface="+mn-lt"/>
          <a:ea typeface="+mn-ea"/>
          <a:cs typeface="+mn-cs"/>
        </a:defRPr>
      </a:lvl7pPr>
      <a:lvl8pPr marL="3931285" algn="l" defTabSz="1123315" rtl="0" eaLnBrk="1" latinLnBrk="0" hangingPunct="1">
        <a:defRPr sz="2210" kern="1200">
          <a:solidFill>
            <a:schemeClr val="tx1"/>
          </a:solidFill>
          <a:latin typeface="+mn-lt"/>
          <a:ea typeface="+mn-ea"/>
          <a:cs typeface="+mn-cs"/>
        </a:defRPr>
      </a:lvl8pPr>
      <a:lvl9pPr marL="4492625" algn="l" defTabSz="1123315" rtl="0" eaLnBrk="1" latinLnBrk="0" hangingPunct="1">
        <a:defRPr sz="221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notesSlide" Target="../notesSlides/notesSlide1.xml"/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1.png"/><Relationship Id="rId2" Type="http://schemas.openxmlformats.org/officeDocument/2006/relationships/chart" Target="../charts/chart2.xml"/><Relationship Id="rId1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组合 14"/>
          <p:cNvGrpSpPr/>
          <p:nvPr/>
        </p:nvGrpSpPr>
        <p:grpSpPr>
          <a:xfrm>
            <a:off x="1295400" y="648000"/>
            <a:ext cx="6715760" cy="8467725"/>
            <a:chOff x="1814" y="1219"/>
            <a:chExt cx="10576" cy="13335"/>
          </a:xfrm>
        </p:grpSpPr>
        <p:sp>
          <p:nvSpPr>
            <p:cNvPr id="8" name="矩形 7"/>
            <p:cNvSpPr/>
            <p:nvPr/>
          </p:nvSpPr>
          <p:spPr>
            <a:xfrm>
              <a:off x="2169" y="6250"/>
              <a:ext cx="623" cy="6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zh-CN" altLang="en-US"/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1814" y="1219"/>
              <a:ext cx="102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814" y="4829"/>
              <a:ext cx="1024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2" name="组合 21"/>
            <p:cNvGrpSpPr/>
            <p:nvPr/>
          </p:nvGrpSpPr>
          <p:grpSpPr>
            <a:xfrm rot="0">
              <a:off x="2569" y="1278"/>
              <a:ext cx="9364" cy="3668"/>
              <a:chOff x="1211" y="-117"/>
              <a:chExt cx="7059" cy="3107"/>
            </a:xfrm>
          </p:grpSpPr>
          <p:grpSp>
            <p:nvGrpSpPr>
              <p:cNvPr id="13" name="组合 12"/>
              <p:cNvGrpSpPr/>
              <p:nvPr/>
            </p:nvGrpSpPr>
            <p:grpSpPr>
              <a:xfrm>
                <a:off x="1211" y="-117"/>
                <a:ext cx="7059" cy="3107"/>
                <a:chOff x="872" y="436"/>
                <a:chExt cx="7059" cy="2860"/>
              </a:xfrm>
            </p:grpSpPr>
            <p:pic>
              <p:nvPicPr>
                <p:cNvPr id="8196" name="Picture 3"/>
                <p:cNvPicPr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031" y="568"/>
                  <a:ext cx="6900" cy="2728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4" name="矩形 3"/>
                <p:cNvSpPr/>
                <p:nvPr/>
              </p:nvSpPr>
              <p:spPr>
                <a:xfrm>
                  <a:off x="872" y="436"/>
                  <a:ext cx="489" cy="455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zh-CN" altLang="en-US"/>
                </a:p>
              </p:txBody>
            </p:sp>
            <p:sp>
              <p:nvSpPr>
                <p:cNvPr id="9" name="矩形 8"/>
                <p:cNvSpPr/>
                <p:nvPr/>
              </p:nvSpPr>
              <p:spPr>
                <a:xfrm>
                  <a:off x="6401" y="436"/>
                  <a:ext cx="491" cy="455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zh-CN" altLang="en-US"/>
                </a:p>
              </p:txBody>
            </p:sp>
            <p:sp>
              <p:nvSpPr>
                <p:cNvPr id="10" name="矩形 9"/>
                <p:cNvSpPr/>
                <p:nvPr/>
              </p:nvSpPr>
              <p:spPr>
                <a:xfrm>
                  <a:off x="1031" y="2841"/>
                  <a:ext cx="489" cy="455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p>
                  <a:pPr algn="ctr">
                    <a:defRPr/>
                  </a:pPr>
                  <a:endParaRPr lang="zh-CN" altLang="en-US"/>
                </a:p>
              </p:txBody>
            </p:sp>
          </p:grpSp>
          <p:sp>
            <p:nvSpPr>
              <p:cNvPr id="18" name="文本框 17"/>
              <p:cNvSpPr txBox="1"/>
              <p:nvPr/>
            </p:nvSpPr>
            <p:spPr>
              <a:xfrm>
                <a:off x="1219" y="680"/>
                <a:ext cx="772" cy="149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p>
                <a:pPr algn="ctr" fontAlgn="auto">
                  <a:lnSpc>
                    <a:spcPts val="1600"/>
                  </a:lnSpc>
                </a:pPr>
                <a:r>
                  <a:rPr lang="en-US" altLang="zh-CN" sz="12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  <a:endParaRPr lang="en-US" altLang="zh-CN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 fontAlgn="auto">
                  <a:lnSpc>
                    <a:spcPts val="1600"/>
                  </a:lnSpc>
                </a:pPr>
                <a:endParaRPr lang="en-US" altLang="zh-CN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 fontAlgn="auto">
                  <a:lnSpc>
                    <a:spcPts val="1600"/>
                  </a:lnSpc>
                </a:pPr>
                <a:endParaRPr lang="en-US" altLang="zh-CN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 fontAlgn="auto">
                  <a:lnSpc>
                    <a:spcPts val="1600"/>
                  </a:lnSpc>
                </a:pPr>
                <a:endParaRPr lang="en-US" altLang="zh-CN" sz="1200" b="1" i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 fontAlgn="auto">
                  <a:lnSpc>
                    <a:spcPts val="1600"/>
                  </a:lnSpc>
                </a:pPr>
                <a:r>
                  <a:rPr lang="en-US" altLang="zh-CN" sz="1200" b="1" i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o14</a:t>
                </a:r>
                <a:endParaRPr lang="en-US" altLang="zh-CN" sz="1200" b="1" i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文本框 18"/>
              <p:cNvSpPr txBox="1"/>
              <p:nvPr/>
            </p:nvSpPr>
            <p:spPr>
              <a:xfrm>
                <a:off x="6975" y="1854"/>
                <a:ext cx="1197" cy="34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p>
                <a:r>
                  <a:rPr lang="en-US" altLang="zh-CN" sz="1100" b="1">
                    <a:solidFill>
                      <a:schemeClr val="tx1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WT    </a:t>
                </a:r>
                <a:r>
                  <a:rPr lang="en-US" altLang="zh-CN" sz="1100" b="1" i="1">
                    <a:solidFill>
                      <a:schemeClr val="tx1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lo14</a:t>
                </a:r>
                <a:endParaRPr lang="en-US" altLang="zh-CN" sz="1100" b="1" i="1">
                  <a:solidFill>
                    <a:schemeClr val="tx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文本框 19"/>
              <p:cNvSpPr txBox="1"/>
              <p:nvPr/>
            </p:nvSpPr>
            <p:spPr>
              <a:xfrm>
                <a:off x="6976" y="136"/>
                <a:ext cx="1294" cy="36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2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 M</a:t>
                </a:r>
                <a:endParaRPr lang="en-US" altLang="zh-CN" sz="12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aphicFrame>
          <p:nvGraphicFramePr>
            <p:cNvPr id="2" name="图表 1"/>
            <p:cNvGraphicFramePr/>
            <p:nvPr/>
          </p:nvGraphicFramePr>
          <p:xfrm>
            <a:off x="2856" y="5219"/>
            <a:ext cx="9534" cy="41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"/>
            </a:graphicData>
          </a:graphic>
        </p:graphicFrame>
        <p:sp>
          <p:nvSpPr>
            <p:cNvPr id="7" name="文本框 6"/>
            <p:cNvSpPr txBox="1"/>
            <p:nvPr/>
          </p:nvSpPr>
          <p:spPr>
            <a:xfrm rot="10800000">
              <a:off x="2402" y="5063"/>
              <a:ext cx="627" cy="4066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p>
              <a:pPr algn="ctr"/>
              <a:r>
                <a:rPr lang="en-US" altLang="zh-CN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welling volume (uL)</a:t>
              </a:r>
              <a:endParaRPr lang="en-US" altLang="zh-CN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814" y="9920"/>
              <a:ext cx="104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/>
            <p:cNvSpPr txBox="1"/>
            <p:nvPr/>
          </p:nvSpPr>
          <p:spPr>
            <a:xfrm rot="10800000">
              <a:off x="2204" y="10193"/>
              <a:ext cx="627" cy="312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p>
              <a:pPr algn="ctr"/>
              <a:r>
                <a:rPr lang="en-US" altLang="zh-CN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iscosity (cP)</a:t>
              </a:r>
              <a:endParaRPr lang="en-US" altLang="zh-CN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 rot="10800000">
              <a:off x="11576" y="9920"/>
              <a:ext cx="627" cy="384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p>
              <a:pPr algn="ctr"/>
              <a:r>
                <a:rPr lang="en-US" altLang="zh-CN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emperature (℃)</a:t>
              </a:r>
              <a:endParaRPr lang="en-US" altLang="zh-CN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14" name="图表 13"/>
            <p:cNvGraphicFramePr/>
            <p:nvPr/>
          </p:nvGraphicFramePr>
          <p:xfrm>
            <a:off x="2630" y="9678"/>
            <a:ext cx="8992" cy="487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</p:grpSp>
      <p:sp>
        <p:nvSpPr>
          <p:cNvPr id="5" name="文本框 4"/>
          <p:cNvSpPr txBox="1"/>
          <p:nvPr/>
        </p:nvSpPr>
        <p:spPr>
          <a:xfrm>
            <a:off x="1083310" y="9270365"/>
            <a:ext cx="7157720" cy="16300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fontAlgn="auto">
              <a:lnSpc>
                <a:spcPts val="2000"/>
              </a:lnSpc>
            </a:pPr>
            <a:r>
              <a:rPr lang="zh-CN" alt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 Comparison of starch physicochemical features. (</a:t>
            </a:r>
            <a:r>
              <a:rPr lang="zh-CN" alt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) Starch powder mixed with urea solution of the wild type (WT) and </a:t>
            </a:r>
            <a:r>
              <a:rPr lang="zh-CN" altLang="en-US" sz="1600" i="1">
                <a:latin typeface="Times New Roman" panose="02020603050405020304" pitchFamily="18" charset="0"/>
                <a:cs typeface="Times New Roman" panose="02020603050405020304" pitchFamily="18" charset="0"/>
              </a:rPr>
              <a:t>flo14</a:t>
            </a:r>
            <a:r>
              <a: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 mutant </a:t>
            </a:r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600" i="1">
                <a:latin typeface="Times New Roman" panose="02020603050405020304" pitchFamily="18" charset="0"/>
                <a:cs typeface="Times New Roman" panose="02020603050405020304" pitchFamily="18" charset="0"/>
              </a:rPr>
              <a:t>flo14</a:t>
            </a:r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 in different concentrations from 0 M to 9 M. (</a:t>
            </a:r>
            <a:r>
              <a:rPr lang="zh-CN" alt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) Comparison of swelling volume of the wild type and </a:t>
            </a:r>
            <a:r>
              <a:rPr lang="zh-CN" altLang="en-US" sz="1600" i="1">
                <a:latin typeface="Times New Roman" panose="02020603050405020304" pitchFamily="18" charset="0"/>
                <a:cs typeface="Times New Roman" panose="02020603050405020304" pitchFamily="18" charset="0"/>
              </a:rPr>
              <a:t>flo14</a:t>
            </a:r>
            <a:r>
              <a: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 mutant starch in different urea concentrations from 0 M to 9 M (n = 3 each). (</a:t>
            </a:r>
            <a:r>
              <a:rPr lang="zh-CN" alt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) Pasting properties of starch of the wild type and </a:t>
            </a:r>
            <a:r>
              <a:rPr lang="zh-CN" altLang="en-US" sz="1600" i="1">
                <a:latin typeface="Times New Roman" panose="02020603050405020304" pitchFamily="18" charset="0"/>
                <a:cs typeface="Times New Roman" panose="02020603050405020304" pitchFamily="18" charset="0"/>
              </a:rPr>
              <a:t>flo14</a:t>
            </a:r>
            <a:r>
              <a:rPr lang="zh-CN" alt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 mutant. The red line represents the temperature changed during the measurements.</a:t>
            </a:r>
            <a:endParaRPr lang="zh-CN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48</Words>
  <Application>WPS 演示</Application>
  <PresentationFormat>自定义</PresentationFormat>
  <Paragraphs>24</Paragraphs>
  <Slides>1</Slides>
  <Notes>9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Times New Roman</vt:lpstr>
      <vt:lpstr>Calibri</vt:lpstr>
      <vt:lpstr>微软雅黑</vt:lpstr>
      <vt:lpstr>Arial Unicode MS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中期汇报</dc:title>
  <dc:creator>林诺</dc:creator>
  <cp:lastModifiedBy>林诺</cp:lastModifiedBy>
  <cp:revision>305</cp:revision>
  <dcterms:created xsi:type="dcterms:W3CDTF">2018-09-19T03:36:00Z</dcterms:created>
  <dcterms:modified xsi:type="dcterms:W3CDTF">2019-09-10T11:45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894</vt:lpwstr>
  </property>
</Properties>
</file>